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905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66" d="100"/>
          <a:sy n="66" d="100"/>
        </p:scale>
        <p:origin x="-2192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0D686B-0D0C-7A47-B8CF-4DBAAD762805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45DE6A-6080-C744-A8BC-4E6B91059B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362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0EA945-5336-DC48-8538-CB736C0B48F2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EE405B-B3C2-4B44-A9EC-30B0D809B8F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858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E01F1-9F0E-9447-A8FE-27337010EDF0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26E12D-B4A8-2D4E-8794-0304594864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763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520923-B57F-3D4A-905A-CB9F09264EE3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DE2505-6E1A-F94A-B40C-D042B65C4B0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658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E5B321-1C87-C44C-B412-62C1D800DAC2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4EE689-34D4-E849-8F1D-488287012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509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855A9E-57C6-7541-B23F-0BC26D950CD3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E7E30-D739-EC4E-85BD-14F985C282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118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F5A78B-6582-4546-954D-42CB56548CE5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87C599-3DF4-5646-89B0-A2A9ED3D0D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244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543536-4B38-0647-90ED-F193D353501E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D58540-68A1-C448-9622-CE8DBB88895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685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50F828-3D8E-504C-94B1-AB7E8C223563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4BA744-20C6-A247-B76B-D0CEB7A470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139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B5C3EF-1A1A-3A4F-ACF7-D0874251D8F7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C78DAB-BAFD-074F-BB2E-B4BA5D82F1F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262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nl-BE" noProof="0" smtClean="0"/>
              <a:t>Drag picture to placeholder or click icon to add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BE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0C60C9-DC3D-D34C-83ED-1AF3A754362F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2CA6F8-9E00-404B-B483-5D4A29BF5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333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BE" smtClean="0"/>
              <a:t>Click to edit Master title style</a:t>
            </a:r>
            <a:endParaRPr 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1"/>
            <a:ext cx="6172200" cy="6034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BE" smtClean="0"/>
              <a:t>Click to edit Master text styles</a:t>
            </a:r>
          </a:p>
          <a:p>
            <a:pPr lvl="1"/>
            <a:r>
              <a:rPr lang="nl-BE" smtClean="0"/>
              <a:t>Second level</a:t>
            </a:r>
          </a:p>
          <a:p>
            <a:pPr lvl="2"/>
            <a:r>
              <a:rPr lang="nl-BE" smtClean="0"/>
              <a:t>Third level</a:t>
            </a:r>
          </a:p>
          <a:p>
            <a:pPr lvl="3"/>
            <a:r>
              <a:rPr lang="nl-BE" smtClean="0"/>
              <a:t>Fourth level</a:t>
            </a:r>
          </a:p>
          <a:p>
            <a:pPr lvl="4"/>
            <a:r>
              <a:rPr lang="nl-B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9BE87AC-0BF5-7740-A2AB-BB6E6C176CA0}" type="datetimeFigureOut">
              <a:rPr lang="en-US"/>
              <a:pPr>
                <a:defRPr/>
              </a:pPr>
              <a:t>6/15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D97B401-DBD3-8249-9240-378F9D64910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06" r:id="rId1"/>
    <p:sldLayoutId id="2147483907" r:id="rId2"/>
    <p:sldLayoutId id="2147483908" r:id="rId3"/>
    <p:sldLayoutId id="2147483909" r:id="rId4"/>
    <p:sldLayoutId id="2147483910" r:id="rId5"/>
    <p:sldLayoutId id="2147483911" r:id="rId6"/>
    <p:sldLayoutId id="2147483912" r:id="rId7"/>
    <p:sldLayoutId id="2147483913" r:id="rId8"/>
    <p:sldLayoutId id="2147483914" r:id="rId9"/>
    <p:sldLayoutId id="2147483915" r:id="rId10"/>
    <p:sldLayoutId id="2147483916" r:id="rId11"/>
  </p:sldLayoutIdLst>
  <p:txStyles>
    <p:titleStyle>
      <a:lvl1pPr algn="ctr" defTabSz="457200" rtl="0" eaLnBrk="1" fontAlgn="base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4572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9144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3716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828800" algn="ctr" defTabSz="457200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stribution_interference_distance_physique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5007" y="3058427"/>
            <a:ext cx="5145304" cy="3087182"/>
          </a:xfrm>
          <a:prstGeom prst="rect">
            <a:avLst/>
          </a:prstGeom>
        </p:spPr>
      </p:pic>
      <p:pic>
        <p:nvPicPr>
          <p:cNvPr id="3" name="Picture 2" descr="distribution_interference_distance_genetique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4252" y="367591"/>
            <a:ext cx="5126060" cy="307563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36131" y="63496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460500" y="3511034"/>
            <a:ext cx="798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IL-</a:t>
            </a:r>
            <a:r>
              <a:rPr lang="en-US" dirty="0" err="1" smtClean="0"/>
              <a:t>bp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497216" y="756134"/>
            <a:ext cx="851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IL-</a:t>
            </a:r>
            <a:r>
              <a:rPr lang="en-US" dirty="0" err="1" smtClean="0"/>
              <a:t>cM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-150918" y="1743290"/>
            <a:ext cx="24028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Normalized distance between CO events</a:t>
            </a:r>
            <a:endParaRPr lang="en-US" sz="1050" dirty="0"/>
          </a:p>
        </p:txBody>
      </p:sp>
      <p:sp>
        <p:nvSpPr>
          <p:cNvPr id="8" name="TextBox 7"/>
          <p:cNvSpPr txBox="1"/>
          <p:nvPr/>
        </p:nvSpPr>
        <p:spPr>
          <a:xfrm>
            <a:off x="3201176" y="3127202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GII-sire</a:t>
            </a:r>
            <a:endParaRPr lang="en-US" sz="105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140084" y="4459955"/>
            <a:ext cx="24028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Normalized distance between CO events</a:t>
            </a:r>
            <a:endParaRPr lang="en-US" sz="1050" dirty="0"/>
          </a:p>
        </p:txBody>
      </p:sp>
      <p:sp>
        <p:nvSpPr>
          <p:cNvPr id="12" name="TextBox 11"/>
          <p:cNvSpPr txBox="1"/>
          <p:nvPr/>
        </p:nvSpPr>
        <p:spPr>
          <a:xfrm>
            <a:off x="3135034" y="5824627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GII-sire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26909068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MAIN_FIG05B_V1.png"/>
          <p:cNvPicPr>
            <a:picLocks noChangeAspect="1"/>
          </p:cNvPicPr>
          <p:nvPr/>
        </p:nvPicPr>
        <p:blipFill>
          <a:blip r:embed="rId2"/>
          <a:srcRect l="4815" b="7778"/>
          <a:stretch>
            <a:fillRect/>
          </a:stretch>
        </p:blipFill>
        <p:spPr>
          <a:xfrm>
            <a:off x="3869614" y="274789"/>
            <a:ext cx="2272450" cy="220171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4300" y="10865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pic>
        <p:nvPicPr>
          <p:cNvPr id="4" name="Picture 3" descr="corr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5" b="7949"/>
          <a:stretch/>
        </p:blipFill>
        <p:spPr>
          <a:xfrm>
            <a:off x="749300" y="287489"/>
            <a:ext cx="2286000" cy="22017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422400" y="45156"/>
            <a:ext cx="851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IL-</a:t>
            </a:r>
            <a:r>
              <a:rPr lang="en-US" dirty="0" err="1" smtClean="0"/>
              <a:t>cM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495800" y="45156"/>
            <a:ext cx="798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IL-</a:t>
            </a:r>
            <a:r>
              <a:rPr lang="en-US" dirty="0" err="1" smtClean="0"/>
              <a:t>bp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397000" y="2501900"/>
            <a:ext cx="8173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Dutch sons</a:t>
            </a:r>
            <a:endParaRPr lang="en-US" sz="11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253771" y="1339850"/>
            <a:ext cx="6325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NZ sons</a:t>
            </a:r>
            <a:endParaRPr lang="en-US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4673600" y="2506990"/>
            <a:ext cx="8173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Dutch sons</a:t>
            </a:r>
            <a:endParaRPr lang="en-US" sz="11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3352571" y="1230640"/>
            <a:ext cx="6325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NZ sons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6969398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lodscore_hg_all2_obs_final_figure_interference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500" y="345016"/>
            <a:ext cx="6438900" cy="357716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flipH="1">
            <a:off x="317500" y="190500"/>
            <a:ext cx="40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56058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228</TotalTime>
  <Words>39</Words>
  <Application>Microsoft Macintosh PowerPoint</Application>
  <PresentationFormat>On-screen Show (4:3)</PresentationFormat>
  <Paragraphs>1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Default Theme</vt:lpstr>
      <vt:lpstr>PowerPoint Presentation</vt:lpstr>
      <vt:lpstr>PowerPoint Presentation</vt:lpstr>
      <vt:lpstr>PowerPoint Presentation</vt:lpstr>
    </vt:vector>
  </TitlesOfParts>
  <Company>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f ice</dc:creator>
  <cp:lastModifiedBy>off ice</cp:lastModifiedBy>
  <cp:revision>9</cp:revision>
  <dcterms:created xsi:type="dcterms:W3CDTF">2012-02-22T16:43:10Z</dcterms:created>
  <dcterms:modified xsi:type="dcterms:W3CDTF">2012-06-15T16:44:07Z</dcterms:modified>
</cp:coreProperties>
</file>